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9" autoAdjust="0"/>
    <p:restoredTop sz="94660"/>
  </p:normalViewPr>
  <p:slideViewPr>
    <p:cSldViewPr snapToGrid="0">
      <p:cViewPr varScale="1">
        <p:scale>
          <a:sx n="75" d="100"/>
          <a:sy n="75" d="100"/>
        </p:scale>
        <p:origin x="8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684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722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660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53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420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682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273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721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729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38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5712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FDB929-2CDF-478F-8F9C-BC2013C147D8}" type="datetimeFigureOut">
              <a:rPr lang="en-US" smtClean="0"/>
              <a:t>4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1389B8-3412-4CC0-B895-7EFC2BC1E7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57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405187" y="2042138"/>
            <a:ext cx="8322353" cy="4308864"/>
            <a:chOff x="387080" y="1007007"/>
            <a:chExt cx="8322353" cy="4308864"/>
          </a:xfrm>
        </p:grpSpPr>
        <p:sp>
          <p:nvSpPr>
            <p:cNvPr id="6" name="Left Brace 5"/>
            <p:cNvSpPr/>
            <p:nvPr/>
          </p:nvSpPr>
          <p:spPr>
            <a:xfrm rot="5400000">
              <a:off x="4168013" y="775249"/>
              <a:ext cx="272374" cy="1683175"/>
            </a:xfrm>
            <a:prstGeom prst="lef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7080" y="1806958"/>
              <a:ext cx="8322353" cy="2766538"/>
            </a:xfrm>
            <a:prstGeom prst="rect">
              <a:avLst/>
            </a:prstGeom>
          </p:spPr>
        </p:pic>
        <p:sp>
          <p:nvSpPr>
            <p:cNvPr id="8" name="Left Brace 7"/>
            <p:cNvSpPr/>
            <p:nvPr/>
          </p:nvSpPr>
          <p:spPr>
            <a:xfrm rot="5400000">
              <a:off x="1293136" y="775249"/>
              <a:ext cx="272374" cy="1683175"/>
            </a:xfrm>
            <a:prstGeom prst="lef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Left Brace 8"/>
            <p:cNvSpPr/>
            <p:nvPr/>
          </p:nvSpPr>
          <p:spPr>
            <a:xfrm rot="5400000">
              <a:off x="7042890" y="775249"/>
              <a:ext cx="272374" cy="1683175"/>
            </a:xfrm>
            <a:prstGeom prst="lef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077303" y="1012296"/>
              <a:ext cx="7040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MR-1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091449" y="1007007"/>
              <a:ext cx="4255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Y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774959" y="1007007"/>
              <a:ext cx="8082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DHL92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81405" y="4566780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468745" y="4566779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366204" y="5008094"/>
              <a:ext cx="4820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NTC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87735" y="4566781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175075" y="4566778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746339" y="4566777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E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25583" y="4566775"/>
              <a:ext cx="266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F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572674" y="4566780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160014" y="4566779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279004" y="4566781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866344" y="4566778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437608" y="4566777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E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716852" y="4566775"/>
              <a:ext cx="266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F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730640" y="4566780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317980" y="4566779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436970" y="4566781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024310" y="4566778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595574" y="4566777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E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874818" y="4566775"/>
              <a:ext cx="266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F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609572" y="4566774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315902" y="4566775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433258" y="4566774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139588" y="4566773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036097" y="4566773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E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8315341" y="4566771"/>
              <a:ext cx="266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F</a:t>
              </a:r>
            </a:p>
          </p:txBody>
        </p:sp>
        <p:sp>
          <p:nvSpPr>
            <p:cNvPr id="39" name="Left Brace 38"/>
            <p:cNvSpPr/>
            <p:nvPr/>
          </p:nvSpPr>
          <p:spPr>
            <a:xfrm rot="16200000" flipV="1">
              <a:off x="2562168" y="4689820"/>
              <a:ext cx="82251" cy="424467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Left Brace 39"/>
            <p:cNvSpPr/>
            <p:nvPr/>
          </p:nvSpPr>
          <p:spPr>
            <a:xfrm rot="16200000" flipV="1">
              <a:off x="5395421" y="4670586"/>
              <a:ext cx="82251" cy="424467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Left Brace 40"/>
            <p:cNvSpPr/>
            <p:nvPr/>
          </p:nvSpPr>
          <p:spPr>
            <a:xfrm rot="16200000" flipV="1">
              <a:off x="8271010" y="4689819"/>
              <a:ext cx="82251" cy="424467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192230" y="5008093"/>
              <a:ext cx="4820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NTC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8074313" y="5008094"/>
              <a:ext cx="4820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NTC</a:t>
              </a:r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1645146" y="282499"/>
            <a:ext cx="11137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RIMERS: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773812" y="287812"/>
            <a:ext cx="2383409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 – FOM2 exon</a:t>
            </a:r>
          </a:p>
          <a:p>
            <a:r>
              <a:rPr lang="en-US" b="1" dirty="0"/>
              <a:t>B -  FOM2 exon</a:t>
            </a:r>
          </a:p>
          <a:p>
            <a:r>
              <a:rPr lang="en-US" b="1" dirty="0"/>
              <a:t>C – Insertion Boundary</a:t>
            </a:r>
          </a:p>
          <a:p>
            <a:r>
              <a:rPr lang="en-US" b="1" dirty="0"/>
              <a:t>D – Insertion boundary</a:t>
            </a:r>
          </a:p>
          <a:p>
            <a:r>
              <a:rPr lang="en-US" b="1" dirty="0"/>
              <a:t>E – Null insertion</a:t>
            </a:r>
          </a:p>
          <a:p>
            <a:r>
              <a:rPr lang="en-US" b="1" dirty="0"/>
              <a:t>F – Null Insertion</a:t>
            </a:r>
          </a:p>
        </p:txBody>
      </p:sp>
    </p:spTree>
    <p:extLst>
      <p:ext uri="{BB962C8B-B14F-4D97-AF65-F5344CB8AC3E}">
        <p14:creationId xmlns:p14="http://schemas.microsoft.com/office/powerpoint/2010/main" val="3157098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</TotalTime>
  <Words>56</Words>
  <Application>Microsoft Macintosh PowerPoint</Application>
  <PresentationFormat>Letter Paper (8.5x11 in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ick Wechter</dc:creator>
  <cp:lastModifiedBy>Vaughn, Justin - ARS</cp:lastModifiedBy>
  <cp:revision>3</cp:revision>
  <dcterms:created xsi:type="dcterms:W3CDTF">2022-04-06T19:22:04Z</dcterms:created>
  <dcterms:modified xsi:type="dcterms:W3CDTF">2022-04-07T16:43:18Z</dcterms:modified>
</cp:coreProperties>
</file>